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1" r:id="rId2"/>
    <p:sldId id="262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219"/>
    <p:restoredTop sz="94729"/>
  </p:normalViewPr>
  <p:slideViewPr>
    <p:cSldViewPr snapToGrid="0">
      <p:cViewPr varScale="1">
        <p:scale>
          <a:sx n="83" d="100"/>
          <a:sy n="83" d="100"/>
        </p:scale>
        <p:origin x="232" y="7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/Users/araiseiji/Desktop/2025_Ureterosciatic%20hernia_Case%20Report/&#22823;&#27941;&#12289;&#22528;&#12289;&#22352;&#39592;&#23380;&#23615;&#31649;&#12504;&#12523;&#12491;&#12450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4240079281778772"/>
          <c:y val="0.15437609749446837"/>
          <c:w val="0.82903155359758007"/>
          <c:h val="0.65339067271380302"/>
        </c:manualLayout>
      </c:layout>
      <c:lineChart>
        <c:grouping val="standard"/>
        <c:varyColors val="0"/>
        <c:ser>
          <c:idx val="1"/>
          <c:order val="0"/>
          <c:tx>
            <c:strRef>
              <c:f>Sheet2!$E$2</c:f>
              <c:strCache>
                <c:ptCount val="1"/>
                <c:pt idx="0">
                  <c:v>eGFR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numRef>
              <c:f>Sheet2!$C$3:$C$43</c:f>
              <c:numCache>
                <c:formatCode>General</c:formatCode>
                <c:ptCount val="4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</c:numCache>
            </c:numRef>
          </c:cat>
          <c:val>
            <c:numRef>
              <c:f>Sheet2!$E$3:$E$43</c:f>
              <c:numCache>
                <c:formatCode>General</c:formatCode>
                <c:ptCount val="41"/>
                <c:pt idx="0">
                  <c:v>60.2</c:v>
                </c:pt>
                <c:pt idx="1">
                  <c:v>58.4</c:v>
                </c:pt>
                <c:pt idx="4">
                  <c:v>72.2</c:v>
                </c:pt>
                <c:pt idx="5">
                  <c:v>73.5</c:v>
                </c:pt>
                <c:pt idx="6">
                  <c:v>34.9</c:v>
                </c:pt>
                <c:pt idx="7">
                  <c:v>44.3</c:v>
                </c:pt>
                <c:pt idx="8">
                  <c:v>42.3</c:v>
                </c:pt>
                <c:pt idx="9">
                  <c:v>41.4</c:v>
                </c:pt>
                <c:pt idx="10">
                  <c:v>48.1</c:v>
                </c:pt>
                <c:pt idx="11">
                  <c:v>49.4</c:v>
                </c:pt>
                <c:pt idx="12">
                  <c:v>56.5</c:v>
                </c:pt>
                <c:pt idx="13">
                  <c:v>23</c:v>
                </c:pt>
                <c:pt idx="14">
                  <c:v>48.1</c:v>
                </c:pt>
                <c:pt idx="15">
                  <c:v>47</c:v>
                </c:pt>
                <c:pt idx="16">
                  <c:v>55.7</c:v>
                </c:pt>
                <c:pt idx="17">
                  <c:v>56.5</c:v>
                </c:pt>
                <c:pt idx="18">
                  <c:v>47.4</c:v>
                </c:pt>
                <c:pt idx="19">
                  <c:v>46.8</c:v>
                </c:pt>
                <c:pt idx="20">
                  <c:v>45.1</c:v>
                </c:pt>
                <c:pt idx="21">
                  <c:v>46.8</c:v>
                </c:pt>
                <c:pt idx="22">
                  <c:v>45.1</c:v>
                </c:pt>
                <c:pt idx="23">
                  <c:v>49.8</c:v>
                </c:pt>
                <c:pt idx="24">
                  <c:v>44.6</c:v>
                </c:pt>
                <c:pt idx="25">
                  <c:v>49.2</c:v>
                </c:pt>
                <c:pt idx="26">
                  <c:v>51.1</c:v>
                </c:pt>
                <c:pt idx="27">
                  <c:v>54.7</c:v>
                </c:pt>
                <c:pt idx="29">
                  <c:v>48.5</c:v>
                </c:pt>
                <c:pt idx="30">
                  <c:v>46</c:v>
                </c:pt>
                <c:pt idx="32">
                  <c:v>41.5</c:v>
                </c:pt>
                <c:pt idx="33">
                  <c:v>47.2</c:v>
                </c:pt>
                <c:pt idx="34">
                  <c:v>38.200000000000003</c:v>
                </c:pt>
                <c:pt idx="35">
                  <c:v>45</c:v>
                </c:pt>
                <c:pt idx="36">
                  <c:v>48.4</c:v>
                </c:pt>
                <c:pt idx="38">
                  <c:v>53</c:v>
                </c:pt>
                <c:pt idx="39">
                  <c:v>50.3</c:v>
                </c:pt>
                <c:pt idx="40">
                  <c:v>51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1CB-7641-AE23-A2A1D19668C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37209296"/>
        <c:axId val="837211024"/>
      </c:lineChart>
      <c:catAx>
        <c:axId val="8372092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en-US"/>
          </a:p>
        </c:txPr>
        <c:crossAx val="837211024"/>
        <c:crosses val="autoZero"/>
        <c:auto val="1"/>
        <c:lblAlgn val="ctr"/>
        <c:lblOffset val="40"/>
        <c:tickLblSkip val="6"/>
        <c:noMultiLvlLbl val="0"/>
      </c:catAx>
      <c:valAx>
        <c:axId val="837211024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en-US"/>
          </a:p>
        </c:txPr>
        <c:crossAx val="837209296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span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1AAE312-722B-C540-BACD-434E79648FFC}" type="datetimeFigureOut">
              <a:rPr kumimoji="1" lang="ja-JP" altLang="en-US" smtClean="0"/>
              <a:t>2025/8/2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835875F-B540-4643-AA3E-D896447873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29413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13ECABD-51F6-4690-9E18-134C09EAFAE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DECFBF4A-C2AB-48BE-8555-E10C846074F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CFB6604-EFB0-47B4-9098-42C89B245E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383A3C-90DA-43D1-9C79-89FF0781FD53}" type="datetimeFigureOut">
              <a:rPr kumimoji="1" lang="ja-JP" altLang="en-US" smtClean="0"/>
              <a:t>2025/8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9A98155-0DE1-4D24-A31F-F17503B7DD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04CF9F4-BD20-49C5-B6A2-B5ABECCCF6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F4C7C-BFA2-4EA2-8821-276FB6D8D4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25203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5C96B36-C7ED-47CF-A325-66332472E2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17D13B5-7FB1-49A5-B96E-E60C951393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98FC934-044C-44D1-8E03-4EDCA5AA6A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383A3C-90DA-43D1-9C79-89FF0781FD53}" type="datetimeFigureOut">
              <a:rPr kumimoji="1" lang="ja-JP" altLang="en-US" smtClean="0"/>
              <a:t>2025/8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28D36A2-27B2-485E-A5C3-CB8542117E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4E7957F-1514-4E70-943C-E590FFF246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F4C7C-BFA2-4EA2-8821-276FB6D8D4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41260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370A4802-CDDC-4B66-AF42-266A0F2D12D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658219F-A857-4CE0-87C5-F021D7031C7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FE1A75A-3A8F-4ADA-8BBD-ED98C31DC3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383A3C-90DA-43D1-9C79-89FF0781FD53}" type="datetimeFigureOut">
              <a:rPr kumimoji="1" lang="ja-JP" altLang="en-US" smtClean="0"/>
              <a:t>2025/8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520FA91-B7D6-4BBF-B6F2-F96F86F31E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3AA69F6-3F89-4ECC-B11C-022118611F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F4C7C-BFA2-4EA2-8821-276FB6D8D4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90315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6AA76E6-AC5B-47C4-A80F-F9FE736017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E63DA0E-D00A-4CD0-B383-1A67C701301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0A377B7-1D3A-488C-964F-5DA96292D0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383A3C-90DA-43D1-9C79-89FF0781FD53}" type="datetimeFigureOut">
              <a:rPr kumimoji="1" lang="ja-JP" altLang="en-US" smtClean="0"/>
              <a:t>2025/8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ABA8C1E-5923-4AB3-B402-44E3CAA6CA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8BE9E53-33D1-4BE4-915F-E243075AE2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F4C7C-BFA2-4EA2-8821-276FB6D8D4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8346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D4EC3A2-A2B3-42F7-A1F4-3CD2607A5A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CB06BD2-243A-49CE-B805-8D6C69D4C3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8A457A1-E67E-4F79-80F5-D475DA3586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383A3C-90DA-43D1-9C79-89FF0781FD53}" type="datetimeFigureOut">
              <a:rPr kumimoji="1" lang="ja-JP" altLang="en-US" smtClean="0"/>
              <a:t>2025/8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99273D3-E933-405A-924B-61A4CFB53F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F80F7A0-C07E-4327-AB3D-8C6D55D031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F4C7C-BFA2-4EA2-8821-276FB6D8D4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89780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596231D-8470-42CA-BD29-922EE07533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794533F-7B7C-4BC5-A1C0-AF619A117FD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8811DEA-115D-4C29-8DC3-56C12134AC9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9061B0E-F9A2-4D68-93FC-4887868D8E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383A3C-90DA-43D1-9C79-89FF0781FD53}" type="datetimeFigureOut">
              <a:rPr kumimoji="1" lang="ja-JP" altLang="en-US" smtClean="0"/>
              <a:t>2025/8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C8768C7-1B99-4B1F-B5F7-36A320A65A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1C9AF80-DEEA-4825-A501-2602CB954F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F4C7C-BFA2-4EA2-8821-276FB6D8D4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81850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84926C2-CE9B-4194-9615-B4690A5D5A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86DC1AF-B251-4B78-94DC-EB3987760A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39904DA-7D75-4046-8A3B-4D56C0B567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E8617876-F087-4BFF-868C-B6EC12801A2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56D6E308-CE90-478B-BD48-9E93BDB03EB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A10E0530-F612-48F9-AB73-6A90B81BBB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383A3C-90DA-43D1-9C79-89FF0781FD53}" type="datetimeFigureOut">
              <a:rPr kumimoji="1" lang="ja-JP" altLang="en-US" smtClean="0"/>
              <a:t>2025/8/2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EC2FD3C3-D0CA-4119-8E43-6E358C38BB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F4714D8D-2ACD-4215-A837-5BF0490A3D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F4C7C-BFA2-4EA2-8821-276FB6D8D4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63833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B760454-6C42-4B66-A446-666AC8D005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879B05DE-866D-4DE2-A1B0-1A8955B7F3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383A3C-90DA-43D1-9C79-89FF0781FD53}" type="datetimeFigureOut">
              <a:rPr kumimoji="1" lang="ja-JP" altLang="en-US" smtClean="0"/>
              <a:t>2025/8/2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43111A31-9AFD-471F-90C2-37C835ABA3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A5711C07-B8A9-4BAC-B60A-3EF3F8164B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F4C7C-BFA2-4EA2-8821-276FB6D8D4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21684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BE987340-B17F-4F99-AECA-E0A356F347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383A3C-90DA-43D1-9C79-89FF0781FD53}" type="datetimeFigureOut">
              <a:rPr kumimoji="1" lang="ja-JP" altLang="en-US" smtClean="0"/>
              <a:t>2025/8/2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4EB015D7-513A-47A4-AF0D-35361DE145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4966BE8-7597-46A5-A6EC-CFCB552EF7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F4C7C-BFA2-4EA2-8821-276FB6D8D4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88479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E4B5098-2CC0-41CC-8597-1113A108AE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60C57E5-304C-4435-8DFC-FA4BF875EEE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54D6743-3F38-4FB9-9EBC-FC370917567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A0D35CA-8D71-4C84-9579-CD85C27220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383A3C-90DA-43D1-9C79-89FF0781FD53}" type="datetimeFigureOut">
              <a:rPr kumimoji="1" lang="ja-JP" altLang="en-US" smtClean="0"/>
              <a:t>2025/8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2AFB9A4-ADA1-40D0-84F7-76EF257774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A882433-C962-463D-B6A2-A4F2186859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F4C7C-BFA2-4EA2-8821-276FB6D8D4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27912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704612F-C5A8-47C6-99BF-39C4FF704B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B3032497-3AB9-44A2-B7AE-AD1F136F318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521998E-E558-47F4-A17E-F341BCD8490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0FE8AEC-D34C-4BEC-9B73-2F1B06679C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383A3C-90DA-43D1-9C79-89FF0781FD53}" type="datetimeFigureOut">
              <a:rPr kumimoji="1" lang="ja-JP" altLang="en-US" smtClean="0"/>
              <a:t>2025/8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CD1F16C-C6C1-4343-94C5-25173FECF0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EDFF1BE-7530-4B11-B3A1-F0CCF6FD5D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F4C7C-BFA2-4EA2-8821-276FB6D8D4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76394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52F4B821-D98D-4AD4-9610-9A86429C2D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D83EBE0-1442-4F48-BAFE-3A0D1400C6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D49F4E0-DB4C-42E2-BB4C-F3B99063822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383A3C-90DA-43D1-9C79-89FF0781FD53}" type="datetimeFigureOut">
              <a:rPr kumimoji="1" lang="ja-JP" altLang="en-US" smtClean="0"/>
              <a:t>2025/8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A4C4E3E-F473-4D80-8C13-D747D7D41E1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2E8FF40-AAB5-4E13-BC74-3BE476655C5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4F4C7C-BFA2-4EA2-8821-276FB6D8D4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23608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テキスト ボックス 9">
            <a:extLst>
              <a:ext uri="{FF2B5EF4-FFF2-40B4-BE49-F238E27FC236}">
                <a16:creationId xmlns:a16="http://schemas.microsoft.com/office/drawing/2014/main" id="{F429E84A-D03C-FEB6-D0AC-AE4581353261}"/>
              </a:ext>
            </a:extLst>
          </p:cNvPr>
          <p:cNvSpPr txBox="1"/>
          <p:nvPr/>
        </p:nvSpPr>
        <p:spPr>
          <a:xfrm>
            <a:off x="401763" y="155028"/>
            <a:ext cx="4052042" cy="57996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2400" b="1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Supplemental Figure 1</a:t>
            </a:r>
          </a:p>
        </p:txBody>
      </p:sp>
      <p:grpSp>
        <p:nvGrpSpPr>
          <p:cNvPr id="22" name="Group 21">
            <a:extLst>
              <a:ext uri="{FF2B5EF4-FFF2-40B4-BE49-F238E27FC236}">
                <a16:creationId xmlns:a16="http://schemas.microsoft.com/office/drawing/2014/main" id="{46734540-06E8-40C4-FEFA-AF8D4F6BEDFD}"/>
              </a:ext>
            </a:extLst>
          </p:cNvPr>
          <p:cNvGrpSpPr/>
          <p:nvPr/>
        </p:nvGrpSpPr>
        <p:grpSpPr>
          <a:xfrm>
            <a:off x="1652094" y="1646867"/>
            <a:ext cx="8330106" cy="3964376"/>
            <a:chOff x="1652094" y="1646867"/>
            <a:chExt cx="8330106" cy="3964376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2D3DC827-D065-DBC5-CA84-63B90A1E49E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209800" y="1646867"/>
              <a:ext cx="7772400" cy="3564266"/>
            </a:xfrm>
            <a:prstGeom prst="rect">
              <a:avLst/>
            </a:prstGeom>
          </p:spPr>
        </p:pic>
        <p:sp>
          <p:nvSpPr>
            <p:cNvPr id="7" name="テキスト ボックス 15">
              <a:extLst>
                <a:ext uri="{FF2B5EF4-FFF2-40B4-BE49-F238E27FC236}">
                  <a16:creationId xmlns:a16="http://schemas.microsoft.com/office/drawing/2014/main" id="{FD7866EA-7CAB-DE09-DE06-DA44E54620AD}"/>
                </a:ext>
              </a:extLst>
            </p:cNvPr>
            <p:cNvSpPr txBox="1"/>
            <p:nvPr/>
          </p:nvSpPr>
          <p:spPr>
            <a:xfrm>
              <a:off x="6036040" y="5211133"/>
              <a:ext cx="598241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2000" dirty="0">
                  <a:latin typeface="Helvetica" pitchFamily="2" charset="0"/>
                  <a:cs typeface="Times New Roman" panose="02020603050405020304" pitchFamily="18" charset="0"/>
                </a:rPr>
                <a:t>min</a:t>
              </a:r>
              <a:endParaRPr kumimoji="1" lang="ja-JP" altLang="en-US" sz="2000">
                <a:latin typeface="Helvetica" pitchFamily="2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テキスト ボックス 14">
              <a:extLst>
                <a:ext uri="{FF2B5EF4-FFF2-40B4-BE49-F238E27FC236}">
                  <a16:creationId xmlns:a16="http://schemas.microsoft.com/office/drawing/2014/main" id="{749EDFBF-0F82-7661-EEB9-6619E7EF7219}"/>
                </a:ext>
              </a:extLst>
            </p:cNvPr>
            <p:cNvSpPr txBox="1"/>
            <p:nvPr/>
          </p:nvSpPr>
          <p:spPr>
            <a:xfrm rot="16200000">
              <a:off x="1182735" y="2996997"/>
              <a:ext cx="1338828" cy="40011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altLang="ja-JP" sz="2000" dirty="0">
                  <a:latin typeface="Helvetica" pitchFamily="2" charset="0"/>
                  <a:cs typeface="Times New Roman" panose="02020603050405020304" pitchFamily="18" charset="0"/>
                </a:rPr>
                <a:t>Count/sec</a:t>
              </a:r>
              <a:endParaRPr kumimoji="1" lang="ja-JP" altLang="en-US" sz="2000">
                <a:latin typeface="Helvetica" pitchFamily="2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BDA9EFA9-AF2E-AE73-DC3C-EE5E8FEE8446}"/>
                </a:ext>
              </a:extLst>
            </p:cNvPr>
            <p:cNvSpPr txBox="1"/>
            <p:nvPr/>
          </p:nvSpPr>
          <p:spPr>
            <a:xfrm>
              <a:off x="3841137" y="1872588"/>
              <a:ext cx="612668" cy="30777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400" b="1" dirty="0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ight</a:t>
              </a:r>
              <a:endParaRPr kumimoji="1" lang="ja-JP" altLang="en-US" sz="1400" b="1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テキスト ボックス 12">
              <a:extLst>
                <a:ext uri="{FF2B5EF4-FFF2-40B4-BE49-F238E27FC236}">
                  <a16:creationId xmlns:a16="http://schemas.microsoft.com/office/drawing/2014/main" id="{A2BCA109-3557-8CCB-6751-73114BA071A6}"/>
                </a:ext>
              </a:extLst>
            </p:cNvPr>
            <p:cNvSpPr txBox="1"/>
            <p:nvPr/>
          </p:nvSpPr>
          <p:spPr>
            <a:xfrm>
              <a:off x="5532377" y="2889275"/>
              <a:ext cx="503663" cy="30777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4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</a:t>
              </a:r>
              <a:r>
                <a:rPr lang="en-US" altLang="ja-JP" sz="14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ft</a:t>
              </a:r>
              <a:endParaRPr kumimoji="1" lang="ja-JP" altLang="en-US" sz="1400" b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3974467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9">
            <a:extLst>
              <a:ext uri="{FF2B5EF4-FFF2-40B4-BE49-F238E27FC236}">
                <a16:creationId xmlns:a16="http://schemas.microsoft.com/office/drawing/2014/main" id="{D90CDD18-5F58-400F-C430-BE109F18C8A2}"/>
              </a:ext>
            </a:extLst>
          </p:cNvPr>
          <p:cNvSpPr txBox="1"/>
          <p:nvPr/>
        </p:nvSpPr>
        <p:spPr>
          <a:xfrm>
            <a:off x="401763" y="155028"/>
            <a:ext cx="3907083" cy="57996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2400" b="1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Supplemental Figure 2</a:t>
            </a:r>
          </a:p>
        </p:txBody>
      </p:sp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FE442086-3EAA-23A2-D17F-4BD564A1DDC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30652856"/>
              </p:ext>
            </p:extLst>
          </p:nvPr>
        </p:nvGraphicFramePr>
        <p:xfrm>
          <a:off x="1745730" y="1397581"/>
          <a:ext cx="8700539" cy="52097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テキスト ボックス 14">
            <a:extLst>
              <a:ext uri="{FF2B5EF4-FFF2-40B4-BE49-F238E27FC236}">
                <a16:creationId xmlns:a16="http://schemas.microsoft.com/office/drawing/2014/main" id="{94B259EB-C9F4-C0FD-D6F2-62F8816BE9C7}"/>
              </a:ext>
            </a:extLst>
          </p:cNvPr>
          <p:cNvSpPr txBox="1"/>
          <p:nvPr/>
        </p:nvSpPr>
        <p:spPr>
          <a:xfrm rot="16200000">
            <a:off x="743767" y="3662790"/>
            <a:ext cx="2621230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Helvetica" pitchFamily="2" charset="0"/>
                <a:cs typeface="Times New Roman" panose="02020603050405020304" pitchFamily="18" charset="0"/>
              </a:rPr>
              <a:t>eGFR (mL/min/1.73m²) </a:t>
            </a:r>
            <a:endParaRPr kumimoji="1" lang="ja-JP" altLang="en-US">
              <a:latin typeface="Helvetica" pitchFamily="2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15">
            <a:extLst>
              <a:ext uri="{FF2B5EF4-FFF2-40B4-BE49-F238E27FC236}">
                <a16:creationId xmlns:a16="http://schemas.microsoft.com/office/drawing/2014/main" id="{8FD09BFD-7C1C-6AFC-8580-1DC1AF55F8E5}"/>
              </a:ext>
            </a:extLst>
          </p:cNvPr>
          <p:cNvSpPr txBox="1"/>
          <p:nvPr/>
        </p:nvSpPr>
        <p:spPr>
          <a:xfrm>
            <a:off x="5986126" y="6207187"/>
            <a:ext cx="1024640" cy="4001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2000" dirty="0">
                <a:latin typeface="Helvetica" pitchFamily="2" charset="0"/>
                <a:cs typeface="Times New Roman" panose="02020603050405020304" pitchFamily="18" charset="0"/>
              </a:rPr>
              <a:t>months</a:t>
            </a:r>
            <a:endParaRPr kumimoji="1" lang="ja-JP" altLang="en-US" sz="2000">
              <a:latin typeface="Helvetica" pitchFamily="2" charset="0"/>
              <a:cs typeface="Times New Roman" panose="02020603050405020304" pitchFamily="18" charset="0"/>
            </a:endParaRP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2B586223-4332-1F9D-26E6-AF40450624B2}"/>
              </a:ext>
            </a:extLst>
          </p:cNvPr>
          <p:cNvCxnSpPr>
            <a:cxnSpLocks/>
          </p:cNvCxnSpPr>
          <p:nvPr/>
        </p:nvCxnSpPr>
        <p:spPr>
          <a:xfrm>
            <a:off x="3239146" y="1508456"/>
            <a:ext cx="0" cy="1885672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D883D34A-580F-F98F-94C9-BA3EDAB43367}"/>
              </a:ext>
            </a:extLst>
          </p:cNvPr>
          <p:cNvSpPr txBox="1"/>
          <p:nvPr/>
        </p:nvSpPr>
        <p:spPr>
          <a:xfrm>
            <a:off x="2239049" y="1139124"/>
            <a:ext cx="2069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Helvetica" pitchFamily="2" charset="0"/>
              </a:rPr>
              <a:t>Cerebral infarction</a:t>
            </a: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A9E285DC-E3BB-4B6B-3ED8-2EEBBE1B1573}"/>
              </a:ext>
            </a:extLst>
          </p:cNvPr>
          <p:cNvCxnSpPr>
            <a:cxnSpLocks/>
          </p:cNvCxnSpPr>
          <p:nvPr/>
        </p:nvCxnSpPr>
        <p:spPr>
          <a:xfrm>
            <a:off x="3949485" y="2070270"/>
            <a:ext cx="0" cy="902875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67861E4C-003D-0E9E-4556-2CE7BD6F9B3B}"/>
              </a:ext>
            </a:extLst>
          </p:cNvPr>
          <p:cNvSpPr txBox="1"/>
          <p:nvPr/>
        </p:nvSpPr>
        <p:spPr>
          <a:xfrm>
            <a:off x="3426388" y="1700938"/>
            <a:ext cx="34163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Helvetica" pitchFamily="2" charset="0"/>
              </a:rPr>
              <a:t>Coronary artery bypass surgery</a:t>
            </a:r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F34035CB-6AAC-32D4-09B6-72712B32D827}"/>
              </a:ext>
            </a:extLst>
          </p:cNvPr>
          <p:cNvCxnSpPr>
            <a:cxnSpLocks/>
          </p:cNvCxnSpPr>
          <p:nvPr/>
        </p:nvCxnSpPr>
        <p:spPr>
          <a:xfrm>
            <a:off x="5372746" y="3099662"/>
            <a:ext cx="0" cy="982254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2A9EA363-B8F6-C112-B686-4EFD8696EF1F}"/>
              </a:ext>
            </a:extLst>
          </p:cNvPr>
          <p:cNvSpPr txBox="1"/>
          <p:nvPr/>
        </p:nvSpPr>
        <p:spPr>
          <a:xfrm>
            <a:off x="4239244" y="2623496"/>
            <a:ext cx="33906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Helvetica" pitchFamily="2" charset="0"/>
              </a:rPr>
              <a:t>Emphysematous pyelonephritis</a:t>
            </a:r>
          </a:p>
        </p:txBody>
      </p:sp>
    </p:spTree>
    <p:extLst>
      <p:ext uri="{BB962C8B-B14F-4D97-AF65-F5344CB8AC3E}">
        <p14:creationId xmlns:p14="http://schemas.microsoft.com/office/powerpoint/2010/main" val="34248172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Yu Gothic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55</TotalTime>
  <Words>29</Words>
  <Application>Microsoft Macintosh PowerPoint</Application>
  <PresentationFormat>Widescreen</PresentationFormat>
  <Paragraphs>1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游ゴシック</vt:lpstr>
      <vt:lpstr>游ゴシック Light</vt:lpstr>
      <vt:lpstr>Arial</vt:lpstr>
      <vt:lpstr>Helvetica</vt:lpstr>
      <vt:lpstr>Times New Roman</vt:lpstr>
      <vt:lpstr>Office テーマ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UD57140</dc:creator>
  <cp:lastModifiedBy>誠二 新井</cp:lastModifiedBy>
  <cp:revision>20</cp:revision>
  <dcterms:created xsi:type="dcterms:W3CDTF">2023-01-23T13:12:12Z</dcterms:created>
  <dcterms:modified xsi:type="dcterms:W3CDTF">2025-08-21T03:04:05Z</dcterms:modified>
</cp:coreProperties>
</file>